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D86"/>
    <a:srgbClr val="5A0680"/>
    <a:srgbClr val="CC04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A4CF31C-CFCF-42CF-93F7-1676001CA9E5}" v="4" dt="2024-06-12T07:53:41.9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e Dorothee Müller" userId="ab964034-1f01-4177-a0db-fb7a7cc00aa4" providerId="ADAL" clId="{EA4CF31C-CFCF-42CF-93F7-1676001CA9E5}"/>
    <pc:docChg chg="undo custSel delSld modSld">
      <pc:chgData name="Anne Dorothee Müller" userId="ab964034-1f01-4177-a0db-fb7a7cc00aa4" providerId="ADAL" clId="{EA4CF31C-CFCF-42CF-93F7-1676001CA9E5}" dt="2024-06-25T11:43:19.842" v="168" actId="47"/>
      <pc:docMkLst>
        <pc:docMk/>
      </pc:docMkLst>
      <pc:sldChg chg="del">
        <pc:chgData name="Anne Dorothee Müller" userId="ab964034-1f01-4177-a0db-fb7a7cc00aa4" providerId="ADAL" clId="{EA4CF31C-CFCF-42CF-93F7-1676001CA9E5}" dt="2024-06-25T11:43:19.842" v="168" actId="47"/>
        <pc:sldMkLst>
          <pc:docMk/>
          <pc:sldMk cId="478252404" sldId="256"/>
        </pc:sldMkLst>
      </pc:sldChg>
      <pc:sldChg chg="addSp modSp mod">
        <pc:chgData name="Anne Dorothee Müller" userId="ab964034-1f01-4177-a0db-fb7a7cc00aa4" providerId="ADAL" clId="{EA4CF31C-CFCF-42CF-93F7-1676001CA9E5}" dt="2024-06-24T06:38:13.989" v="167" actId="20577"/>
        <pc:sldMkLst>
          <pc:docMk/>
          <pc:sldMk cId="4080635466" sldId="257"/>
        </pc:sldMkLst>
        <pc:spChg chg="add mod">
          <ac:chgData name="Anne Dorothee Müller" userId="ab964034-1f01-4177-a0db-fb7a7cc00aa4" providerId="ADAL" clId="{EA4CF31C-CFCF-42CF-93F7-1676001CA9E5}" dt="2024-06-11T14:55:22.562" v="42" actId="20577"/>
          <ac:spMkLst>
            <pc:docMk/>
            <pc:sldMk cId="4080635466" sldId="257"/>
            <ac:spMk id="2" creationId="{AD724036-32EA-FCBB-E051-474385F198FF}"/>
          </ac:spMkLst>
        </pc:spChg>
        <pc:spChg chg="add mod">
          <ac:chgData name="Anne Dorothee Müller" userId="ab964034-1f01-4177-a0db-fb7a7cc00aa4" providerId="ADAL" clId="{EA4CF31C-CFCF-42CF-93F7-1676001CA9E5}" dt="2024-06-11T14:55:25.880" v="45" actId="20577"/>
          <ac:spMkLst>
            <pc:docMk/>
            <pc:sldMk cId="4080635466" sldId="257"/>
            <ac:spMk id="3" creationId="{F94DD699-BC93-BBF1-4798-85F4F363C32F}"/>
          </ac:spMkLst>
        </pc:spChg>
        <pc:spChg chg="mod">
          <ac:chgData name="Anne Dorothee Müller" userId="ab964034-1f01-4177-a0db-fb7a7cc00aa4" providerId="ADAL" clId="{EA4CF31C-CFCF-42CF-93F7-1676001CA9E5}" dt="2024-06-24T06:38:13.989" v="167" actId="20577"/>
          <ac:spMkLst>
            <pc:docMk/>
            <pc:sldMk cId="4080635466" sldId="257"/>
            <ac:spMk id="4" creationId="{3A82FBBD-AA09-748C-B958-D37CE8D6403B}"/>
          </ac:spMkLst>
        </pc:spChg>
        <pc:spChg chg="add mod">
          <ac:chgData name="Anne Dorothee Müller" userId="ab964034-1f01-4177-a0db-fb7a7cc00aa4" providerId="ADAL" clId="{EA4CF31C-CFCF-42CF-93F7-1676001CA9E5}" dt="2024-06-11T14:55:32.761" v="49" actId="20577"/>
          <ac:spMkLst>
            <pc:docMk/>
            <pc:sldMk cId="4080635466" sldId="257"/>
            <ac:spMk id="5" creationId="{CAD7E45F-AB0F-68E0-0B61-FAEAE3362CB6}"/>
          </ac:spMkLst>
        </pc:spChg>
        <pc:spChg chg="mod">
          <ac:chgData name="Anne Dorothee Müller" userId="ab964034-1f01-4177-a0db-fb7a7cc00aa4" providerId="ADAL" clId="{EA4CF31C-CFCF-42CF-93F7-1676001CA9E5}" dt="2024-06-24T06:38:02.940" v="151" actId="20577"/>
          <ac:spMkLst>
            <pc:docMk/>
            <pc:sldMk cId="4080635466" sldId="257"/>
            <ac:spMk id="6" creationId="{6974B4B0-98AF-E31E-9B7E-2E538B57FFEC}"/>
          </ac:spMkLst>
        </pc:spChg>
        <pc:spChg chg="add mod">
          <ac:chgData name="Anne Dorothee Müller" userId="ab964034-1f01-4177-a0db-fb7a7cc00aa4" providerId="ADAL" clId="{EA4CF31C-CFCF-42CF-93F7-1676001CA9E5}" dt="2024-06-24T06:25:08.079" v="143" actId="207"/>
          <ac:spMkLst>
            <pc:docMk/>
            <pc:sldMk cId="4080635466" sldId="257"/>
            <ac:spMk id="7" creationId="{C882A7B3-F216-2EA4-2522-44FE522DA04E}"/>
          </ac:spMkLst>
        </pc:spChg>
        <pc:spChg chg="add mod">
          <ac:chgData name="Anne Dorothee Müller" userId="ab964034-1f01-4177-a0db-fb7a7cc00aa4" providerId="ADAL" clId="{EA4CF31C-CFCF-42CF-93F7-1676001CA9E5}" dt="2024-06-24T06:24:57.564" v="140" actId="207"/>
          <ac:spMkLst>
            <pc:docMk/>
            <pc:sldMk cId="4080635466" sldId="257"/>
            <ac:spMk id="8" creationId="{2C11ABBC-4823-7562-A9A7-56F92992A8E8}"/>
          </ac:spMkLst>
        </pc:spChg>
        <pc:spChg chg="mod">
          <ac:chgData name="Anne Dorothee Müller" userId="ab964034-1f01-4177-a0db-fb7a7cc00aa4" providerId="ADAL" clId="{EA4CF31C-CFCF-42CF-93F7-1676001CA9E5}" dt="2024-06-24T06:25:32.113" v="145" actId="208"/>
          <ac:spMkLst>
            <pc:docMk/>
            <pc:sldMk cId="4080635466" sldId="257"/>
            <ac:spMk id="9" creationId="{76DADAD4-EA6A-F292-6A7B-2846D2E443AF}"/>
          </ac:spMkLst>
        </pc:spChg>
        <pc:spChg chg="mod">
          <ac:chgData name="Anne Dorothee Müller" userId="ab964034-1f01-4177-a0db-fb7a7cc00aa4" providerId="ADAL" clId="{EA4CF31C-CFCF-42CF-93F7-1676001CA9E5}" dt="2024-06-24T06:37:34.484" v="148" actId="1076"/>
          <ac:spMkLst>
            <pc:docMk/>
            <pc:sldMk cId="4080635466" sldId="257"/>
            <ac:spMk id="10" creationId="{DD74E3CD-402D-916E-ACDB-13578EE2F65E}"/>
          </ac:spMkLst>
        </pc:spChg>
        <pc:spChg chg="mod">
          <ac:chgData name="Anne Dorothee Müller" userId="ab964034-1f01-4177-a0db-fb7a7cc00aa4" providerId="ADAL" clId="{EA4CF31C-CFCF-42CF-93F7-1676001CA9E5}" dt="2024-06-24T06:37:49.981" v="149" actId="1076"/>
          <ac:spMkLst>
            <pc:docMk/>
            <pc:sldMk cId="4080635466" sldId="257"/>
            <ac:spMk id="11" creationId="{E7EE5998-D033-64D7-228F-EAD4629D2815}"/>
          </ac:spMkLst>
        </pc:spChg>
        <pc:spChg chg="mod">
          <ac:chgData name="Anne Dorothee Müller" userId="ab964034-1f01-4177-a0db-fb7a7cc00aa4" providerId="ADAL" clId="{EA4CF31C-CFCF-42CF-93F7-1676001CA9E5}" dt="2024-06-24T06:37:30.164" v="147" actId="1076"/>
          <ac:spMkLst>
            <pc:docMk/>
            <pc:sldMk cId="4080635466" sldId="257"/>
            <ac:spMk id="12" creationId="{27FE3622-3F39-1F57-C3B7-56B48246AF9C}"/>
          </ac:spMkLst>
        </pc:spChg>
        <pc:cxnChg chg="mod">
          <ac:chgData name="Anne Dorothee Müller" userId="ab964034-1f01-4177-a0db-fb7a7cc00aa4" providerId="ADAL" clId="{EA4CF31C-CFCF-42CF-93F7-1676001CA9E5}" dt="2024-06-24T06:25:10.735" v="144" actId="208"/>
          <ac:cxnSpMkLst>
            <pc:docMk/>
            <pc:sldMk cId="4080635466" sldId="257"/>
            <ac:cxnSpMk id="16" creationId="{C0BF8A8F-BDCF-4906-D21E-2B361C73F0DD}"/>
          </ac:cxnSpMkLst>
        </pc:cxnChg>
        <pc:cxnChg chg="mod">
          <ac:chgData name="Anne Dorothee Müller" userId="ab964034-1f01-4177-a0db-fb7a7cc00aa4" providerId="ADAL" clId="{EA4CF31C-CFCF-42CF-93F7-1676001CA9E5}" dt="2024-06-24T06:25:02.958" v="141" actId="208"/>
          <ac:cxnSpMkLst>
            <pc:docMk/>
            <pc:sldMk cId="4080635466" sldId="257"/>
            <ac:cxnSpMk id="17" creationId="{4D665382-44FE-7D9E-C5C9-C9F677C6A59E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8C493D7-8B8F-705F-0528-0F5B1DAE50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6E5EABBF-B503-6938-B0E6-93B872EC48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41FC20A-E74D-C4A2-898D-AB5ECF90E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7EEB793B-E02F-6933-4DA1-FAB9C5A30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61CBD5EC-554E-6897-82C8-60710578B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1510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9591C6-73BC-8E87-9C71-83F647D9ED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8B1A4811-E9FE-C47D-8900-B9E59F9B10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7E2615E-C9FD-4AFE-1F2B-C63A60949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AF55C7AA-7DDF-A623-7E6C-10F12DF91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E9C0319-1224-6417-E916-A978C7039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65668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065CB5CE-89BB-15B4-2D04-5AE4E2C1B1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FD257CFA-2D07-90CB-2D98-815588B028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1FC49DF-0C11-952C-6A08-A923525BB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1FC9B849-6D99-1766-9930-FD534DD21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73AC3D8-BE8C-17D7-94C5-79C764B37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90126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5FB3D9-2FD2-90AA-DAE3-A0B7EEE4DF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FAF91D46-FD13-8BAD-3689-25FD64A7C9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75F995F3-883A-88F6-6D3F-07E6034F9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2B853FF9-7A8D-0D5F-F18B-1D2E34586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B0F0CE46-23A6-DC24-4C7E-54B8A59D4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2131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893849-00F7-7492-E2F6-8E5406E3A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328927C5-B3AF-D1BA-6DB5-D37F5F5665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D6BE274E-71BA-BD08-BCBC-27D98F0F1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17D8A99-4FF8-97A1-891F-E9624FD55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474BB779-5AE8-D891-3CB8-3E0D24D1A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54346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32DCB38-688D-D675-93A6-D6BF381651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1939B810-BB30-D860-EA09-8AB24544A3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BD4D75FE-2424-4624-0286-E372BB5947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170C7DBE-90E8-F18A-BA3B-6C4697B19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8017335B-EDF8-A4DC-868A-ECC384CAF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E38D121E-42C5-C450-4326-C1937FBA5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7573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95917A5-EFEA-62A9-35D8-15B528492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F43C539C-8952-F5C5-8F83-808FDF47C8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B0EAE9B8-EC77-0AFC-10C9-72679623E5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66DC8047-6983-2F54-C3C2-63DE12C518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243A9C77-08FC-F7D1-ED90-80F7C3E612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BB465F59-CFA8-0544-6293-E5236BB1F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0D931323-B9EC-A367-9C01-256516815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3703B060-7447-B392-EF03-62C573EC7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65056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25DF4D1-0260-D274-EE16-04908D0E53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DB92512A-0333-B38B-CB86-D2D25411A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66151505-AACC-34E4-3C91-F67BE053A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56D52150-C448-03CD-9B17-75C1763AE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90622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CC3C77E9-DDE3-7CEE-7AFA-9DAEB4D1D8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57476290-ACAE-62C3-7016-18A82EF9C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0FAB024B-EBD3-C7ED-A58D-1B9638824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81880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096EC2D-0AA8-B179-769D-F8F721675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BBD4AFF-B9CB-E5C0-AC3E-9BD7CA8AFF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7CEB270F-3ED5-0C6E-7296-E3ADB5A71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08E3CF95-C664-ADB3-4919-57D36797C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2F542633-859D-2D93-B7E6-3189D2675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7F233E83-A7FD-C9F9-0B6E-FA066741B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18945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AD0226D-37F9-F26D-1AC1-E296804DB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F5020CF8-C213-0795-0A5F-4B342D80C8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D81EF4F9-87FB-7520-72B9-A699929AD7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D551CF5E-C1F2-F1E3-D38C-DE25F9140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F79E8EF-DEC1-CAB7-EF9D-11EA32C2B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37B6CD45-C1ED-7E7F-5CE0-65F3432A1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38428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B597FFCE-8F42-F4B8-B49E-8206D8B2B0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8E9889E7-6537-9B17-F793-A7F80FDC15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D039F2C5-EAE3-D5BA-CE5A-C4F51C22D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3AB6E-28E4-44BF-BC73-01B0E909748F}" type="datetimeFigureOut">
              <a:rPr lang="da-DK" smtClean="0"/>
              <a:t>25-06-2024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392F7B44-64E3-776C-7303-EFAF77760E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181C2E44-221E-44F5-BB39-A12A45B64F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DEE367-014A-4768-9514-0F2ECF6D6EFA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27355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llipse 3">
            <a:extLst>
              <a:ext uri="{FF2B5EF4-FFF2-40B4-BE49-F238E27FC236}">
                <a16:creationId xmlns:a16="http://schemas.microsoft.com/office/drawing/2014/main" id="{3A82FBBD-AA09-748C-B958-D37CE8D6403B}"/>
              </a:ext>
            </a:extLst>
          </p:cNvPr>
          <p:cNvSpPr/>
          <p:nvPr/>
        </p:nvSpPr>
        <p:spPr>
          <a:xfrm>
            <a:off x="924560" y="2529840"/>
            <a:ext cx="3098800" cy="1361440"/>
          </a:xfrm>
          <a:custGeom>
            <a:avLst/>
            <a:gdLst>
              <a:gd name="connsiteX0" fmla="*/ 0 w 3098800"/>
              <a:gd name="connsiteY0" fmla="*/ 680720 h 1361440"/>
              <a:gd name="connsiteX1" fmla="*/ 1549400 w 3098800"/>
              <a:gd name="connsiteY1" fmla="*/ 0 h 1361440"/>
              <a:gd name="connsiteX2" fmla="*/ 3098800 w 3098800"/>
              <a:gd name="connsiteY2" fmla="*/ 680720 h 1361440"/>
              <a:gd name="connsiteX3" fmla="*/ 1549400 w 3098800"/>
              <a:gd name="connsiteY3" fmla="*/ 1361440 h 1361440"/>
              <a:gd name="connsiteX4" fmla="*/ 0 w 3098800"/>
              <a:gd name="connsiteY4" fmla="*/ 680720 h 13614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098800" h="1361440" extrusionOk="0">
                <a:moveTo>
                  <a:pt x="0" y="680720"/>
                </a:moveTo>
                <a:cubicBezTo>
                  <a:pt x="-29660" y="221852"/>
                  <a:pt x="691012" y="-32496"/>
                  <a:pt x="1549400" y="0"/>
                </a:cubicBezTo>
                <a:cubicBezTo>
                  <a:pt x="2395529" y="-2321"/>
                  <a:pt x="3040243" y="315798"/>
                  <a:pt x="3098800" y="680720"/>
                </a:cubicBezTo>
                <a:cubicBezTo>
                  <a:pt x="3132861" y="1128728"/>
                  <a:pt x="2484013" y="1328664"/>
                  <a:pt x="1549400" y="1361440"/>
                </a:cubicBezTo>
                <a:cubicBezTo>
                  <a:pt x="767431" y="1364929"/>
                  <a:pt x="627" y="1063832"/>
                  <a:pt x="0" y="680720"/>
                </a:cubicBezTo>
                <a:close/>
              </a:path>
            </a:pathLst>
          </a:custGeom>
          <a:noFill/>
          <a:ln>
            <a:solidFill>
              <a:srgbClr val="CC0450"/>
            </a:solidFill>
            <a:extLst>
              <a:ext uri="{C807C97D-BFC1-408E-A445-0C87EB9F89A2}">
                <ask:lineSketchStyleProps xmlns:ask="http://schemas.microsoft.com/office/drawing/2018/sketchyshapes" sd="264327539">
                  <a:prstGeom prst="ellipse">
                    <a:avLst/>
                  </a:prstGeom>
                  <ask:type>
                    <ask:lineSketchCurve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Qualitative</a:t>
            </a:r>
            <a:r>
              <a:rPr lang="da-DK" b="1" dirty="0">
                <a:solidFill>
                  <a:schemeClr val="tx1"/>
                </a:solidFill>
              </a:rPr>
              <a:t> </a:t>
            </a:r>
          </a:p>
          <a:p>
            <a:pPr algn="ctr"/>
            <a:r>
              <a:rPr lang="da-DK">
                <a:solidFill>
                  <a:schemeClr val="tx1"/>
                </a:solidFill>
              </a:rPr>
              <a:t>Data Generation </a:t>
            </a:r>
            <a:r>
              <a:rPr lang="da-DK" dirty="0">
                <a:solidFill>
                  <a:schemeClr val="tx1"/>
                </a:solidFill>
              </a:rPr>
              <a:t>and Analysis</a:t>
            </a:r>
          </a:p>
        </p:txBody>
      </p:sp>
      <p:sp>
        <p:nvSpPr>
          <p:cNvPr id="6" name="Ellipse 5">
            <a:extLst>
              <a:ext uri="{FF2B5EF4-FFF2-40B4-BE49-F238E27FC236}">
                <a16:creationId xmlns:a16="http://schemas.microsoft.com/office/drawing/2014/main" id="{6974B4B0-98AF-E31E-9B7E-2E538B57FFEC}"/>
              </a:ext>
            </a:extLst>
          </p:cNvPr>
          <p:cNvSpPr/>
          <p:nvPr/>
        </p:nvSpPr>
        <p:spPr>
          <a:xfrm>
            <a:off x="7437120" y="2529840"/>
            <a:ext cx="3098800" cy="1361440"/>
          </a:xfrm>
          <a:custGeom>
            <a:avLst/>
            <a:gdLst>
              <a:gd name="connsiteX0" fmla="*/ 0 w 3098800"/>
              <a:gd name="connsiteY0" fmla="*/ 680720 h 1361440"/>
              <a:gd name="connsiteX1" fmla="*/ 1549400 w 3098800"/>
              <a:gd name="connsiteY1" fmla="*/ 0 h 1361440"/>
              <a:gd name="connsiteX2" fmla="*/ 3098800 w 3098800"/>
              <a:gd name="connsiteY2" fmla="*/ 680720 h 1361440"/>
              <a:gd name="connsiteX3" fmla="*/ 1549400 w 3098800"/>
              <a:gd name="connsiteY3" fmla="*/ 1361440 h 1361440"/>
              <a:gd name="connsiteX4" fmla="*/ 0 w 3098800"/>
              <a:gd name="connsiteY4" fmla="*/ 680720 h 13614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098800" h="1361440" fill="none" extrusionOk="0">
                <a:moveTo>
                  <a:pt x="0" y="680720"/>
                </a:moveTo>
                <a:cubicBezTo>
                  <a:pt x="-133699" y="333260"/>
                  <a:pt x="676213" y="-35712"/>
                  <a:pt x="1549400" y="0"/>
                </a:cubicBezTo>
                <a:cubicBezTo>
                  <a:pt x="2364336" y="82569"/>
                  <a:pt x="3070197" y="288561"/>
                  <a:pt x="3098800" y="680720"/>
                </a:cubicBezTo>
                <a:cubicBezTo>
                  <a:pt x="3083335" y="1125020"/>
                  <a:pt x="2329114" y="1221630"/>
                  <a:pt x="1549400" y="1361440"/>
                </a:cubicBezTo>
                <a:cubicBezTo>
                  <a:pt x="704952" y="1393311"/>
                  <a:pt x="-76416" y="1054745"/>
                  <a:pt x="0" y="680720"/>
                </a:cubicBezTo>
                <a:close/>
              </a:path>
              <a:path w="3098800" h="1361440" stroke="0" extrusionOk="0">
                <a:moveTo>
                  <a:pt x="0" y="680720"/>
                </a:moveTo>
                <a:cubicBezTo>
                  <a:pt x="108168" y="276194"/>
                  <a:pt x="813615" y="126495"/>
                  <a:pt x="1549400" y="0"/>
                </a:cubicBezTo>
                <a:cubicBezTo>
                  <a:pt x="2331982" y="42519"/>
                  <a:pt x="3183110" y="328014"/>
                  <a:pt x="3098800" y="680720"/>
                </a:cubicBezTo>
                <a:cubicBezTo>
                  <a:pt x="3085598" y="1015437"/>
                  <a:pt x="2480992" y="1247778"/>
                  <a:pt x="1549400" y="1361440"/>
                </a:cubicBezTo>
                <a:cubicBezTo>
                  <a:pt x="722977" y="1380900"/>
                  <a:pt x="72694" y="1025613"/>
                  <a:pt x="0" y="680720"/>
                </a:cubicBezTo>
                <a:close/>
              </a:path>
            </a:pathLst>
          </a:custGeom>
          <a:solidFill>
            <a:schemeClr val="bg1"/>
          </a:solidFill>
          <a:ln>
            <a:solidFill>
              <a:srgbClr val="002D86"/>
            </a:solidFill>
            <a:extLst>
              <a:ext uri="{C807C97D-BFC1-408E-A445-0C87EB9F89A2}">
                <ask:lineSketchStyleProps xmlns:ask="http://schemas.microsoft.com/office/drawing/2018/sketchyshapes" sd="363767128">
                  <a:prstGeom prst="ellipse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Quantitative 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Data Collection and Analysis</a:t>
            </a:r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76DADAD4-EA6A-F292-6A7B-2846D2E443AF}"/>
              </a:ext>
            </a:extLst>
          </p:cNvPr>
          <p:cNvSpPr/>
          <p:nvPr/>
        </p:nvSpPr>
        <p:spPr>
          <a:xfrm>
            <a:off x="4622800" y="2092960"/>
            <a:ext cx="2214880" cy="2214880"/>
          </a:xfrm>
          <a:custGeom>
            <a:avLst/>
            <a:gdLst>
              <a:gd name="connsiteX0" fmla="*/ 0 w 2214880"/>
              <a:gd name="connsiteY0" fmla="*/ 0 h 2214880"/>
              <a:gd name="connsiteX1" fmla="*/ 553720 w 2214880"/>
              <a:gd name="connsiteY1" fmla="*/ 0 h 2214880"/>
              <a:gd name="connsiteX2" fmla="*/ 1085291 w 2214880"/>
              <a:gd name="connsiteY2" fmla="*/ 0 h 2214880"/>
              <a:gd name="connsiteX3" fmla="*/ 1661160 w 2214880"/>
              <a:gd name="connsiteY3" fmla="*/ 0 h 2214880"/>
              <a:gd name="connsiteX4" fmla="*/ 2214880 w 2214880"/>
              <a:gd name="connsiteY4" fmla="*/ 0 h 2214880"/>
              <a:gd name="connsiteX5" fmla="*/ 2214880 w 2214880"/>
              <a:gd name="connsiteY5" fmla="*/ 553720 h 2214880"/>
              <a:gd name="connsiteX6" fmla="*/ 2214880 w 2214880"/>
              <a:gd name="connsiteY6" fmla="*/ 1085291 h 2214880"/>
              <a:gd name="connsiteX7" fmla="*/ 2214880 w 2214880"/>
              <a:gd name="connsiteY7" fmla="*/ 1661160 h 2214880"/>
              <a:gd name="connsiteX8" fmla="*/ 2214880 w 2214880"/>
              <a:gd name="connsiteY8" fmla="*/ 2214880 h 2214880"/>
              <a:gd name="connsiteX9" fmla="*/ 1727606 w 2214880"/>
              <a:gd name="connsiteY9" fmla="*/ 2214880 h 2214880"/>
              <a:gd name="connsiteX10" fmla="*/ 1196035 w 2214880"/>
              <a:gd name="connsiteY10" fmla="*/ 2214880 h 2214880"/>
              <a:gd name="connsiteX11" fmla="*/ 598018 w 2214880"/>
              <a:gd name="connsiteY11" fmla="*/ 2214880 h 2214880"/>
              <a:gd name="connsiteX12" fmla="*/ 0 w 2214880"/>
              <a:gd name="connsiteY12" fmla="*/ 2214880 h 2214880"/>
              <a:gd name="connsiteX13" fmla="*/ 0 w 2214880"/>
              <a:gd name="connsiteY13" fmla="*/ 1683309 h 2214880"/>
              <a:gd name="connsiteX14" fmla="*/ 0 w 2214880"/>
              <a:gd name="connsiteY14" fmla="*/ 1085291 h 2214880"/>
              <a:gd name="connsiteX15" fmla="*/ 0 w 2214880"/>
              <a:gd name="connsiteY15" fmla="*/ 509422 h 2214880"/>
              <a:gd name="connsiteX16" fmla="*/ 0 w 2214880"/>
              <a:gd name="connsiteY16" fmla="*/ 0 h 2214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214880" h="2214880" fill="none" extrusionOk="0">
                <a:moveTo>
                  <a:pt x="0" y="0"/>
                </a:moveTo>
                <a:cubicBezTo>
                  <a:pt x="202118" y="-1035"/>
                  <a:pt x="373937" y="-7514"/>
                  <a:pt x="553720" y="0"/>
                </a:cubicBezTo>
                <a:cubicBezTo>
                  <a:pt x="733503" y="7514"/>
                  <a:pt x="879681" y="-9021"/>
                  <a:pt x="1085291" y="0"/>
                </a:cubicBezTo>
                <a:cubicBezTo>
                  <a:pt x="1290901" y="9021"/>
                  <a:pt x="1378093" y="-23177"/>
                  <a:pt x="1661160" y="0"/>
                </a:cubicBezTo>
                <a:cubicBezTo>
                  <a:pt x="1944227" y="23177"/>
                  <a:pt x="2046360" y="-19541"/>
                  <a:pt x="2214880" y="0"/>
                </a:cubicBezTo>
                <a:cubicBezTo>
                  <a:pt x="2202163" y="125730"/>
                  <a:pt x="2208605" y="381272"/>
                  <a:pt x="2214880" y="553720"/>
                </a:cubicBezTo>
                <a:cubicBezTo>
                  <a:pt x="2221155" y="726168"/>
                  <a:pt x="2221759" y="955781"/>
                  <a:pt x="2214880" y="1085291"/>
                </a:cubicBezTo>
                <a:cubicBezTo>
                  <a:pt x="2208001" y="1214801"/>
                  <a:pt x="2220799" y="1496855"/>
                  <a:pt x="2214880" y="1661160"/>
                </a:cubicBezTo>
                <a:cubicBezTo>
                  <a:pt x="2208961" y="1825465"/>
                  <a:pt x="2233850" y="1999878"/>
                  <a:pt x="2214880" y="2214880"/>
                </a:cubicBezTo>
                <a:cubicBezTo>
                  <a:pt x="2087276" y="2214871"/>
                  <a:pt x="1835471" y="2228855"/>
                  <a:pt x="1727606" y="2214880"/>
                </a:cubicBezTo>
                <a:cubicBezTo>
                  <a:pt x="1619741" y="2200905"/>
                  <a:pt x="1417746" y="2232515"/>
                  <a:pt x="1196035" y="2214880"/>
                </a:cubicBezTo>
                <a:cubicBezTo>
                  <a:pt x="974324" y="2197245"/>
                  <a:pt x="778624" y="2211196"/>
                  <a:pt x="598018" y="2214880"/>
                </a:cubicBezTo>
                <a:cubicBezTo>
                  <a:pt x="417412" y="2218564"/>
                  <a:pt x="286329" y="2185365"/>
                  <a:pt x="0" y="2214880"/>
                </a:cubicBezTo>
                <a:cubicBezTo>
                  <a:pt x="18372" y="1988618"/>
                  <a:pt x="26186" y="1793452"/>
                  <a:pt x="0" y="1683309"/>
                </a:cubicBezTo>
                <a:cubicBezTo>
                  <a:pt x="-26186" y="1573166"/>
                  <a:pt x="-27720" y="1308550"/>
                  <a:pt x="0" y="1085291"/>
                </a:cubicBezTo>
                <a:cubicBezTo>
                  <a:pt x="27720" y="862032"/>
                  <a:pt x="20836" y="724053"/>
                  <a:pt x="0" y="509422"/>
                </a:cubicBezTo>
                <a:cubicBezTo>
                  <a:pt x="-20836" y="294791"/>
                  <a:pt x="-22770" y="151556"/>
                  <a:pt x="0" y="0"/>
                </a:cubicBezTo>
                <a:close/>
              </a:path>
              <a:path w="2214880" h="2214880" stroke="0" extrusionOk="0">
                <a:moveTo>
                  <a:pt x="0" y="0"/>
                </a:moveTo>
                <a:cubicBezTo>
                  <a:pt x="188990" y="-24141"/>
                  <a:pt x="414937" y="-28762"/>
                  <a:pt x="575869" y="0"/>
                </a:cubicBezTo>
                <a:cubicBezTo>
                  <a:pt x="736801" y="28762"/>
                  <a:pt x="1006089" y="-26752"/>
                  <a:pt x="1151738" y="0"/>
                </a:cubicBezTo>
                <a:cubicBezTo>
                  <a:pt x="1297387" y="26752"/>
                  <a:pt x="1810666" y="17358"/>
                  <a:pt x="2214880" y="0"/>
                </a:cubicBezTo>
                <a:cubicBezTo>
                  <a:pt x="2239227" y="214564"/>
                  <a:pt x="2235194" y="399922"/>
                  <a:pt x="2214880" y="575869"/>
                </a:cubicBezTo>
                <a:cubicBezTo>
                  <a:pt x="2194566" y="751816"/>
                  <a:pt x="2215492" y="845364"/>
                  <a:pt x="2214880" y="1063142"/>
                </a:cubicBezTo>
                <a:cubicBezTo>
                  <a:pt x="2214268" y="1280920"/>
                  <a:pt x="2222190" y="1424126"/>
                  <a:pt x="2214880" y="1639011"/>
                </a:cubicBezTo>
                <a:cubicBezTo>
                  <a:pt x="2207570" y="1853896"/>
                  <a:pt x="2232987" y="1938215"/>
                  <a:pt x="2214880" y="2214880"/>
                </a:cubicBezTo>
                <a:cubicBezTo>
                  <a:pt x="2112507" y="2196546"/>
                  <a:pt x="1874648" y="2197524"/>
                  <a:pt x="1705458" y="2214880"/>
                </a:cubicBezTo>
                <a:cubicBezTo>
                  <a:pt x="1536268" y="2232236"/>
                  <a:pt x="1276346" y="2205447"/>
                  <a:pt x="1129589" y="2214880"/>
                </a:cubicBezTo>
                <a:cubicBezTo>
                  <a:pt x="982832" y="2224313"/>
                  <a:pt x="813842" y="2228246"/>
                  <a:pt x="553720" y="2214880"/>
                </a:cubicBezTo>
                <a:cubicBezTo>
                  <a:pt x="293598" y="2201514"/>
                  <a:pt x="158064" y="2188549"/>
                  <a:pt x="0" y="2214880"/>
                </a:cubicBezTo>
                <a:cubicBezTo>
                  <a:pt x="-20646" y="2002659"/>
                  <a:pt x="23910" y="1937152"/>
                  <a:pt x="0" y="1705458"/>
                </a:cubicBezTo>
                <a:cubicBezTo>
                  <a:pt x="-23910" y="1473764"/>
                  <a:pt x="2721" y="1456365"/>
                  <a:pt x="0" y="1218184"/>
                </a:cubicBezTo>
                <a:cubicBezTo>
                  <a:pt x="-2721" y="980003"/>
                  <a:pt x="-4702" y="865860"/>
                  <a:pt x="0" y="686613"/>
                </a:cubicBezTo>
                <a:cubicBezTo>
                  <a:pt x="4702" y="507366"/>
                  <a:pt x="-16887" y="275316"/>
                  <a:pt x="0" y="0"/>
                </a:cubicBezTo>
                <a:close/>
              </a:path>
            </a:pathLst>
          </a:custGeom>
          <a:solidFill>
            <a:schemeClr val="bg1"/>
          </a:solidFill>
          <a:ln>
            <a:solidFill>
              <a:srgbClr val="5A0680"/>
            </a:solidFill>
            <a:extLst>
              <a:ext uri="{C807C97D-BFC1-408E-A445-0C87EB9F89A2}">
                <ask:lineSketchStyleProps xmlns:ask="http://schemas.microsoft.com/office/drawing/2018/sketchyshapes" sd="676761181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Mixed Methods </a:t>
            </a:r>
            <a:r>
              <a:rPr lang="en-US" dirty="0">
                <a:solidFill>
                  <a:schemeClr val="tx1"/>
                </a:solidFill>
              </a:rPr>
              <a:t>Integrating qualitative findings for a quantitative study</a:t>
            </a: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DD74E3CD-402D-916E-ACDB-13578EE2F65E}"/>
              </a:ext>
            </a:extLst>
          </p:cNvPr>
          <p:cNvSpPr txBox="1"/>
          <p:nvPr/>
        </p:nvSpPr>
        <p:spPr>
          <a:xfrm>
            <a:off x="1239519" y="5124431"/>
            <a:ext cx="2468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Abductive analysis of focus group discussions</a:t>
            </a:r>
          </a:p>
        </p:txBody>
      </p:sp>
      <p:sp>
        <p:nvSpPr>
          <p:cNvPr id="11" name="Tekstfelt 10">
            <a:extLst>
              <a:ext uri="{FF2B5EF4-FFF2-40B4-BE49-F238E27FC236}">
                <a16:creationId xmlns:a16="http://schemas.microsoft.com/office/drawing/2014/main" id="{E7EE5998-D033-64D7-228F-EAD4629D2815}"/>
              </a:ext>
            </a:extLst>
          </p:cNvPr>
          <p:cNvSpPr txBox="1"/>
          <p:nvPr/>
        </p:nvSpPr>
        <p:spPr>
          <a:xfrm>
            <a:off x="4124882" y="4851441"/>
            <a:ext cx="33349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Identifying a variable based on participants' views (Part I) to test subgroup differences in the effect of the intervention (Part III)</a:t>
            </a:r>
          </a:p>
        </p:txBody>
      </p:sp>
      <p:sp>
        <p:nvSpPr>
          <p:cNvPr id="12" name="Tekstfelt 11">
            <a:extLst>
              <a:ext uri="{FF2B5EF4-FFF2-40B4-BE49-F238E27FC236}">
                <a16:creationId xmlns:a16="http://schemas.microsoft.com/office/drawing/2014/main" id="{27FE3622-3F39-1F57-C3B7-56B48246AF9C}"/>
              </a:ext>
            </a:extLst>
          </p:cNvPr>
          <p:cNvSpPr txBox="1"/>
          <p:nvPr/>
        </p:nvSpPr>
        <p:spPr>
          <a:xfrm>
            <a:off x="7752079" y="5124431"/>
            <a:ext cx="2468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Subgroup analysis of secondary data</a:t>
            </a:r>
          </a:p>
        </p:txBody>
      </p:sp>
      <p:cxnSp>
        <p:nvCxnSpPr>
          <p:cNvPr id="14" name="Lige pilforbindelse 13">
            <a:extLst>
              <a:ext uri="{FF2B5EF4-FFF2-40B4-BE49-F238E27FC236}">
                <a16:creationId xmlns:a16="http://schemas.microsoft.com/office/drawing/2014/main" id="{86394C85-D679-5DE0-B8B1-2B672532F84B}"/>
              </a:ext>
            </a:extLst>
          </p:cNvPr>
          <p:cNvCxnSpPr/>
          <p:nvPr/>
        </p:nvCxnSpPr>
        <p:spPr>
          <a:xfrm>
            <a:off x="7233920" y="7162800"/>
            <a:ext cx="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Lige pilforbindelse 15">
            <a:extLst>
              <a:ext uri="{FF2B5EF4-FFF2-40B4-BE49-F238E27FC236}">
                <a16:creationId xmlns:a16="http://schemas.microsoft.com/office/drawing/2014/main" id="{C0BF8A8F-BDCF-4906-D21E-2B361C73F0DD}"/>
              </a:ext>
            </a:extLst>
          </p:cNvPr>
          <p:cNvCxnSpPr>
            <a:stCxn id="4" idx="6"/>
          </p:cNvCxnSpPr>
          <p:nvPr/>
        </p:nvCxnSpPr>
        <p:spPr>
          <a:xfrm flipV="1">
            <a:off x="4023360" y="3200400"/>
            <a:ext cx="599440" cy="101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Lige pilforbindelse 16">
            <a:extLst>
              <a:ext uri="{FF2B5EF4-FFF2-40B4-BE49-F238E27FC236}">
                <a16:creationId xmlns:a16="http://schemas.microsoft.com/office/drawing/2014/main" id="{4D665382-44FE-7D9E-C5C9-C9F677C6A59E}"/>
              </a:ext>
            </a:extLst>
          </p:cNvPr>
          <p:cNvCxnSpPr/>
          <p:nvPr/>
        </p:nvCxnSpPr>
        <p:spPr>
          <a:xfrm flipV="1">
            <a:off x="6837680" y="3190240"/>
            <a:ext cx="599440" cy="1016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kstfelt 1">
            <a:extLst>
              <a:ext uri="{FF2B5EF4-FFF2-40B4-BE49-F238E27FC236}">
                <a16:creationId xmlns:a16="http://schemas.microsoft.com/office/drawing/2014/main" id="{AD724036-32EA-FCBB-E051-474385F198FF}"/>
              </a:ext>
            </a:extLst>
          </p:cNvPr>
          <p:cNvSpPr txBox="1"/>
          <p:nvPr/>
        </p:nvSpPr>
        <p:spPr>
          <a:xfrm flipH="1">
            <a:off x="1951535" y="918311"/>
            <a:ext cx="1044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art I</a:t>
            </a:r>
          </a:p>
        </p:txBody>
      </p:sp>
      <p:sp>
        <p:nvSpPr>
          <p:cNvPr id="3" name="Tekstfelt 2">
            <a:extLst>
              <a:ext uri="{FF2B5EF4-FFF2-40B4-BE49-F238E27FC236}">
                <a16:creationId xmlns:a16="http://schemas.microsoft.com/office/drawing/2014/main" id="{F94DD699-BC93-BBF1-4798-85F4F363C32F}"/>
              </a:ext>
            </a:extLst>
          </p:cNvPr>
          <p:cNvSpPr txBox="1"/>
          <p:nvPr/>
        </p:nvSpPr>
        <p:spPr>
          <a:xfrm flipH="1">
            <a:off x="5177335" y="918311"/>
            <a:ext cx="1044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art II</a:t>
            </a:r>
          </a:p>
        </p:txBody>
      </p:sp>
      <p:sp>
        <p:nvSpPr>
          <p:cNvPr id="5" name="Tekstfelt 4">
            <a:extLst>
              <a:ext uri="{FF2B5EF4-FFF2-40B4-BE49-F238E27FC236}">
                <a16:creationId xmlns:a16="http://schemas.microsoft.com/office/drawing/2014/main" id="{CAD7E45F-AB0F-68E0-0B61-FAEAE3362CB6}"/>
              </a:ext>
            </a:extLst>
          </p:cNvPr>
          <p:cNvSpPr txBox="1"/>
          <p:nvPr/>
        </p:nvSpPr>
        <p:spPr>
          <a:xfrm flipH="1">
            <a:off x="8464095" y="918311"/>
            <a:ext cx="10448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Part III</a:t>
            </a:r>
          </a:p>
        </p:txBody>
      </p:sp>
      <p:sp>
        <p:nvSpPr>
          <p:cNvPr id="7" name="Ligebenet trekant 6">
            <a:extLst>
              <a:ext uri="{FF2B5EF4-FFF2-40B4-BE49-F238E27FC236}">
                <a16:creationId xmlns:a16="http://schemas.microsoft.com/office/drawing/2014/main" id="{C882A7B3-F216-2EA4-2522-44FE522DA04E}"/>
              </a:ext>
            </a:extLst>
          </p:cNvPr>
          <p:cNvSpPr/>
          <p:nvPr/>
        </p:nvSpPr>
        <p:spPr>
          <a:xfrm rot="19704020">
            <a:off x="4358826" y="3101504"/>
            <a:ext cx="234892" cy="17747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Ligebenet trekant 7">
            <a:extLst>
              <a:ext uri="{FF2B5EF4-FFF2-40B4-BE49-F238E27FC236}">
                <a16:creationId xmlns:a16="http://schemas.microsoft.com/office/drawing/2014/main" id="{2C11ABBC-4823-7562-A9A7-56F92992A8E8}"/>
              </a:ext>
            </a:extLst>
          </p:cNvPr>
          <p:cNvSpPr/>
          <p:nvPr/>
        </p:nvSpPr>
        <p:spPr>
          <a:xfrm rot="19704020">
            <a:off x="7173610" y="3097309"/>
            <a:ext cx="234892" cy="177473"/>
          </a:xfrm>
          <a:prstGeom prst="triangle">
            <a:avLst/>
          </a:prstGeom>
          <a:solidFill>
            <a:schemeClr val="tx1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635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6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>Region Hovedsta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Anne Dorothee Müller</dc:creator>
  <cp:lastModifiedBy>Anne Dorothee Müller</cp:lastModifiedBy>
  <cp:revision>1</cp:revision>
  <dcterms:created xsi:type="dcterms:W3CDTF">2024-06-11T12:30:42Z</dcterms:created>
  <dcterms:modified xsi:type="dcterms:W3CDTF">2024-06-25T11:43:23Z</dcterms:modified>
</cp:coreProperties>
</file>